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eyer, Jaimie" userId="52b312cd-1ab8-4609-b2c6-6d42dc202bb7" providerId="ADAL" clId="{9D9B1532-72FC-4903-AB63-2E912E9EBA84}"/>
    <pc:docChg chg="delSld modSld">
      <pc:chgData name="Meyer, Jaimie" userId="52b312cd-1ab8-4609-b2c6-6d42dc202bb7" providerId="ADAL" clId="{9D9B1532-72FC-4903-AB63-2E912E9EBA84}" dt="2023-01-13T16:27:43.530" v="93" actId="20577"/>
      <pc:docMkLst>
        <pc:docMk/>
      </pc:docMkLst>
      <pc:sldChg chg="del">
        <pc:chgData name="Meyer, Jaimie" userId="52b312cd-1ab8-4609-b2c6-6d42dc202bb7" providerId="ADAL" clId="{9D9B1532-72FC-4903-AB63-2E912E9EBA84}" dt="2023-01-13T16:26:45.692" v="0" actId="47"/>
        <pc:sldMkLst>
          <pc:docMk/>
          <pc:sldMk cId="0" sldId="256"/>
        </pc:sldMkLst>
      </pc:sldChg>
      <pc:sldChg chg="modSp mod">
        <pc:chgData name="Meyer, Jaimie" userId="52b312cd-1ab8-4609-b2c6-6d42dc202bb7" providerId="ADAL" clId="{9D9B1532-72FC-4903-AB63-2E912E9EBA84}" dt="2023-01-13T16:27:43.530" v="93" actId="20577"/>
        <pc:sldMkLst>
          <pc:docMk/>
          <pc:sldMk cId="3925857993" sldId="257"/>
        </pc:sldMkLst>
        <pc:spChg chg="mod">
          <ac:chgData name="Meyer, Jaimie" userId="52b312cd-1ab8-4609-b2c6-6d42dc202bb7" providerId="ADAL" clId="{9D9B1532-72FC-4903-AB63-2E912E9EBA84}" dt="2023-01-13T16:27:08.355" v="23" actId="20577"/>
          <ac:spMkLst>
            <pc:docMk/>
            <pc:sldMk cId="3925857993" sldId="257"/>
            <ac:spMk id="14" creationId="{00000000-0000-0000-0000-000000000000}"/>
          </ac:spMkLst>
        </pc:spChg>
        <pc:spChg chg="mod">
          <ac:chgData name="Meyer, Jaimie" userId="52b312cd-1ab8-4609-b2c6-6d42dc202bb7" providerId="ADAL" clId="{9D9B1532-72FC-4903-AB63-2E912E9EBA84}" dt="2023-01-13T16:27:43.530" v="93" actId="20577"/>
          <ac:spMkLst>
            <pc:docMk/>
            <pc:sldMk cId="3925857993" sldId="257"/>
            <ac:spMk id="15" creationId="{00000000-0000-0000-0000-000000000000}"/>
          </ac:spMkLst>
        </pc:spChg>
      </pc:sldChg>
    </pc:docChg>
  </pc:docChgLst>
</pc:chgInfo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1">
  <dgm:title val=""/>
  <dgm:desc val=""/>
  <dgm:catLst>
    <dgm:cat type="mainScheme" pri="10100"/>
  </dgm:catLst>
  <dgm:styleLbl name="node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3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4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dk1">
        <a:alpha val="4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1">
        <a:shade val="8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1">
        <a:tint val="50000"/>
        <a:alpha val="4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CF07AAE6-122F-4AD6-90CC-BDBCDC331755}" type="doc">
      <dgm:prSet loTypeId="urn:microsoft.com/office/officeart/2005/8/layout/process1" loCatId="process" qsTypeId="urn:microsoft.com/office/officeart/2005/8/quickstyle/simple1" qsCatId="simple" csTypeId="urn:microsoft.com/office/officeart/2005/8/colors/accent0_1" csCatId="mainScheme" phldr="1"/>
      <dgm:spPr/>
    </dgm:pt>
    <dgm:pt modelId="{705DA90C-267D-4D59-8961-F8B26A858496}">
      <dgm:prSet phldrT="[Text]"/>
      <dgm:spPr/>
      <dgm:t>
        <a:bodyPr/>
        <a:lstStyle/>
        <a:p>
          <a:r>
            <a:rPr lang="en-US" dirty="0"/>
            <a:t>Predisposing Factors</a:t>
          </a:r>
        </a:p>
      </dgm:t>
    </dgm:pt>
    <dgm:pt modelId="{5CA0673E-3FC5-411B-B375-62298329E15B}" type="parTrans" cxnId="{A6647C8C-18AE-48CE-8154-E08E9E7762ED}">
      <dgm:prSet/>
      <dgm:spPr/>
      <dgm:t>
        <a:bodyPr/>
        <a:lstStyle/>
        <a:p>
          <a:endParaRPr lang="en-US"/>
        </a:p>
      </dgm:t>
    </dgm:pt>
    <dgm:pt modelId="{1BEA45E0-89BB-481D-A983-D4B6D90D90A4}" type="sibTrans" cxnId="{A6647C8C-18AE-48CE-8154-E08E9E7762ED}">
      <dgm:prSet/>
      <dgm:spPr/>
      <dgm:t>
        <a:bodyPr/>
        <a:lstStyle/>
        <a:p>
          <a:endParaRPr lang="en-US"/>
        </a:p>
      </dgm:t>
    </dgm:pt>
    <dgm:pt modelId="{7045E4F2-72E6-450B-8DE7-598E5D7E4594}">
      <dgm:prSet phldrT="[Text]"/>
      <dgm:spPr/>
      <dgm:t>
        <a:bodyPr/>
        <a:lstStyle/>
        <a:p>
          <a:r>
            <a:rPr lang="en-US" dirty="0"/>
            <a:t>Enabling Resources</a:t>
          </a:r>
        </a:p>
      </dgm:t>
    </dgm:pt>
    <dgm:pt modelId="{1DA3073F-B1AC-4E55-B1D3-EFE2AAFDFD2F}" type="parTrans" cxnId="{2C7E7138-25A5-4217-AD6E-503474A2AC59}">
      <dgm:prSet/>
      <dgm:spPr/>
      <dgm:t>
        <a:bodyPr/>
        <a:lstStyle/>
        <a:p>
          <a:endParaRPr lang="en-US"/>
        </a:p>
      </dgm:t>
    </dgm:pt>
    <dgm:pt modelId="{F116878C-F31D-478B-9F77-16D7C00AC1F9}" type="sibTrans" cxnId="{2C7E7138-25A5-4217-AD6E-503474A2AC59}">
      <dgm:prSet/>
      <dgm:spPr/>
      <dgm:t>
        <a:bodyPr/>
        <a:lstStyle/>
        <a:p>
          <a:endParaRPr lang="en-US"/>
        </a:p>
      </dgm:t>
    </dgm:pt>
    <dgm:pt modelId="{6318386F-9E96-40DA-8D98-407E11F42F4A}">
      <dgm:prSet phldrT="[Text]"/>
      <dgm:spPr/>
      <dgm:t>
        <a:bodyPr/>
        <a:lstStyle/>
        <a:p>
          <a:r>
            <a:rPr lang="en-US" dirty="0"/>
            <a:t>Need Factors</a:t>
          </a:r>
        </a:p>
      </dgm:t>
    </dgm:pt>
    <dgm:pt modelId="{94C1C45B-7B4B-41BC-AC32-30BF633424E6}" type="parTrans" cxnId="{65F4282B-A6C3-4285-BE90-DBEE8E76FED0}">
      <dgm:prSet/>
      <dgm:spPr/>
      <dgm:t>
        <a:bodyPr/>
        <a:lstStyle/>
        <a:p>
          <a:endParaRPr lang="en-US"/>
        </a:p>
      </dgm:t>
    </dgm:pt>
    <dgm:pt modelId="{95ECC4C7-6AC0-429A-AEC5-D0DA3EBFE0B9}" type="sibTrans" cxnId="{65F4282B-A6C3-4285-BE90-DBEE8E76FED0}">
      <dgm:prSet/>
      <dgm:spPr/>
      <dgm:t>
        <a:bodyPr/>
        <a:lstStyle/>
        <a:p>
          <a:endParaRPr lang="en-US"/>
        </a:p>
      </dgm:t>
    </dgm:pt>
    <dgm:pt modelId="{DD83FD64-FD53-4F09-9D39-6FE26D4990D2}">
      <dgm:prSet/>
      <dgm:spPr>
        <a:solidFill>
          <a:schemeClr val="tx1"/>
        </a:solidFill>
      </dgm:spPr>
      <dgm:t>
        <a:bodyPr/>
        <a:lstStyle/>
        <a:p>
          <a:r>
            <a:rPr lang="en-US" dirty="0">
              <a:solidFill>
                <a:schemeClr val="bg1"/>
              </a:solidFill>
            </a:rPr>
            <a:t>Housing</a:t>
          </a:r>
        </a:p>
      </dgm:t>
    </dgm:pt>
    <dgm:pt modelId="{4D8037E1-1C75-40FD-AFE8-942ED90BD0A8}" type="parTrans" cxnId="{CAB2D949-C447-45FA-94A6-13AB49C4B95E}">
      <dgm:prSet/>
      <dgm:spPr/>
      <dgm:t>
        <a:bodyPr/>
        <a:lstStyle/>
        <a:p>
          <a:endParaRPr lang="en-US"/>
        </a:p>
      </dgm:t>
    </dgm:pt>
    <dgm:pt modelId="{0D2E2804-FD8D-4D74-89AD-E7D1CABE3B57}" type="sibTrans" cxnId="{CAB2D949-C447-45FA-94A6-13AB49C4B95E}">
      <dgm:prSet/>
      <dgm:spPr/>
      <dgm:t>
        <a:bodyPr/>
        <a:lstStyle/>
        <a:p>
          <a:endParaRPr lang="en-US"/>
        </a:p>
      </dgm:t>
    </dgm:pt>
    <dgm:pt modelId="{1A26A498-D97C-49EF-8F4E-A6A2FFA833E2}">
      <dgm:prSet/>
      <dgm:spPr/>
      <dgm:t>
        <a:bodyPr/>
        <a:lstStyle/>
        <a:p>
          <a:r>
            <a:rPr lang="en-US" dirty="0"/>
            <a:t>Health Outcomes</a:t>
          </a:r>
        </a:p>
      </dgm:t>
    </dgm:pt>
    <dgm:pt modelId="{98980F17-6CF5-4CFA-B416-0215B511AE16}" type="parTrans" cxnId="{A7DAC6C9-AF78-4274-BC5E-5F638AD2C5D1}">
      <dgm:prSet/>
      <dgm:spPr/>
      <dgm:t>
        <a:bodyPr/>
        <a:lstStyle/>
        <a:p>
          <a:endParaRPr lang="en-US"/>
        </a:p>
      </dgm:t>
    </dgm:pt>
    <dgm:pt modelId="{BF2B0CE0-3F73-4158-861B-CAA6F767EC0F}" type="sibTrans" cxnId="{A7DAC6C9-AF78-4274-BC5E-5F638AD2C5D1}">
      <dgm:prSet/>
      <dgm:spPr/>
      <dgm:t>
        <a:bodyPr/>
        <a:lstStyle/>
        <a:p>
          <a:endParaRPr lang="en-US"/>
        </a:p>
      </dgm:t>
    </dgm:pt>
    <dgm:pt modelId="{3D1E8515-5E79-4693-978E-9DD5E43EDFAE}" type="pres">
      <dgm:prSet presAssocID="{CF07AAE6-122F-4AD6-90CC-BDBCDC331755}" presName="Name0" presStyleCnt="0">
        <dgm:presLayoutVars>
          <dgm:dir/>
          <dgm:resizeHandles val="exact"/>
        </dgm:presLayoutVars>
      </dgm:prSet>
      <dgm:spPr/>
    </dgm:pt>
    <dgm:pt modelId="{F98B9AFC-39E9-4CDC-9292-6EDB4D4E4403}" type="pres">
      <dgm:prSet presAssocID="{705DA90C-267D-4D59-8961-F8B26A858496}" presName="node" presStyleLbl="node1" presStyleIdx="0" presStyleCnt="5">
        <dgm:presLayoutVars>
          <dgm:bulletEnabled val="1"/>
        </dgm:presLayoutVars>
      </dgm:prSet>
      <dgm:spPr/>
    </dgm:pt>
    <dgm:pt modelId="{17FCE802-51CE-435D-BE7E-10EBFFCD3809}" type="pres">
      <dgm:prSet presAssocID="{1BEA45E0-89BB-481D-A983-D4B6D90D90A4}" presName="sibTrans" presStyleLbl="sibTrans2D1" presStyleIdx="0" presStyleCnt="4"/>
      <dgm:spPr/>
    </dgm:pt>
    <dgm:pt modelId="{0626D2F3-D392-41C8-B3FE-0857B8A26122}" type="pres">
      <dgm:prSet presAssocID="{1BEA45E0-89BB-481D-A983-D4B6D90D90A4}" presName="connectorText" presStyleLbl="sibTrans2D1" presStyleIdx="0" presStyleCnt="4"/>
      <dgm:spPr/>
    </dgm:pt>
    <dgm:pt modelId="{56162AD2-B567-454C-AB3C-001077BCAF23}" type="pres">
      <dgm:prSet presAssocID="{7045E4F2-72E6-450B-8DE7-598E5D7E4594}" presName="node" presStyleLbl="node1" presStyleIdx="1" presStyleCnt="5">
        <dgm:presLayoutVars>
          <dgm:bulletEnabled val="1"/>
        </dgm:presLayoutVars>
      </dgm:prSet>
      <dgm:spPr/>
    </dgm:pt>
    <dgm:pt modelId="{BCC09537-3A97-4B53-8182-E47C506C141F}" type="pres">
      <dgm:prSet presAssocID="{F116878C-F31D-478B-9F77-16D7C00AC1F9}" presName="sibTrans" presStyleLbl="sibTrans2D1" presStyleIdx="1" presStyleCnt="4"/>
      <dgm:spPr/>
    </dgm:pt>
    <dgm:pt modelId="{4070EE5B-9ED8-4397-A618-526423166C08}" type="pres">
      <dgm:prSet presAssocID="{F116878C-F31D-478B-9F77-16D7C00AC1F9}" presName="connectorText" presStyleLbl="sibTrans2D1" presStyleIdx="1" presStyleCnt="4"/>
      <dgm:spPr/>
    </dgm:pt>
    <dgm:pt modelId="{80B437F7-B408-4317-B58D-D788B0F1D79B}" type="pres">
      <dgm:prSet presAssocID="{6318386F-9E96-40DA-8D98-407E11F42F4A}" presName="node" presStyleLbl="node1" presStyleIdx="2" presStyleCnt="5">
        <dgm:presLayoutVars>
          <dgm:bulletEnabled val="1"/>
        </dgm:presLayoutVars>
      </dgm:prSet>
      <dgm:spPr/>
    </dgm:pt>
    <dgm:pt modelId="{625E2593-CC1B-403C-B38C-61E1EE1AF309}" type="pres">
      <dgm:prSet presAssocID="{95ECC4C7-6AC0-429A-AEC5-D0DA3EBFE0B9}" presName="sibTrans" presStyleLbl="sibTrans2D1" presStyleIdx="2" presStyleCnt="4"/>
      <dgm:spPr/>
    </dgm:pt>
    <dgm:pt modelId="{30F38EDA-4DBF-41E1-AFE8-03F899F7E4A6}" type="pres">
      <dgm:prSet presAssocID="{95ECC4C7-6AC0-429A-AEC5-D0DA3EBFE0B9}" presName="connectorText" presStyleLbl="sibTrans2D1" presStyleIdx="2" presStyleCnt="4"/>
      <dgm:spPr/>
    </dgm:pt>
    <dgm:pt modelId="{851CF157-95EC-4DDC-9F72-3244BF8B357A}" type="pres">
      <dgm:prSet presAssocID="{DD83FD64-FD53-4F09-9D39-6FE26D4990D2}" presName="node" presStyleLbl="node1" presStyleIdx="3" presStyleCnt="5">
        <dgm:presLayoutVars>
          <dgm:bulletEnabled val="1"/>
        </dgm:presLayoutVars>
      </dgm:prSet>
      <dgm:spPr/>
    </dgm:pt>
    <dgm:pt modelId="{332B608F-EC63-49AE-A360-E6CEF6967F11}" type="pres">
      <dgm:prSet presAssocID="{0D2E2804-FD8D-4D74-89AD-E7D1CABE3B57}" presName="sibTrans" presStyleLbl="sibTrans2D1" presStyleIdx="3" presStyleCnt="4"/>
      <dgm:spPr/>
    </dgm:pt>
    <dgm:pt modelId="{F9FB68F0-8037-4290-8075-26F650EABDB9}" type="pres">
      <dgm:prSet presAssocID="{0D2E2804-FD8D-4D74-89AD-E7D1CABE3B57}" presName="connectorText" presStyleLbl="sibTrans2D1" presStyleIdx="3" presStyleCnt="4"/>
      <dgm:spPr/>
    </dgm:pt>
    <dgm:pt modelId="{92ABC293-A27F-4B09-9E54-5D0C99DB020E}" type="pres">
      <dgm:prSet presAssocID="{1A26A498-D97C-49EF-8F4E-A6A2FFA833E2}" presName="node" presStyleLbl="node1" presStyleIdx="4" presStyleCnt="5">
        <dgm:presLayoutVars>
          <dgm:bulletEnabled val="1"/>
        </dgm:presLayoutVars>
      </dgm:prSet>
      <dgm:spPr/>
    </dgm:pt>
  </dgm:ptLst>
  <dgm:cxnLst>
    <dgm:cxn modelId="{DEF2A90E-F50A-47BD-9986-409C557E7CDC}" type="presOf" srcId="{705DA90C-267D-4D59-8961-F8B26A858496}" destId="{F98B9AFC-39E9-4CDC-9292-6EDB4D4E4403}" srcOrd="0" destOrd="0" presId="urn:microsoft.com/office/officeart/2005/8/layout/process1"/>
    <dgm:cxn modelId="{65F4282B-A6C3-4285-BE90-DBEE8E76FED0}" srcId="{CF07AAE6-122F-4AD6-90CC-BDBCDC331755}" destId="{6318386F-9E96-40DA-8D98-407E11F42F4A}" srcOrd="2" destOrd="0" parTransId="{94C1C45B-7B4B-41BC-AC32-30BF633424E6}" sibTransId="{95ECC4C7-6AC0-429A-AEC5-D0DA3EBFE0B9}"/>
    <dgm:cxn modelId="{5A93572F-A235-4F4C-87D0-A04169CB0FCB}" type="presOf" srcId="{1BEA45E0-89BB-481D-A983-D4B6D90D90A4}" destId="{0626D2F3-D392-41C8-B3FE-0857B8A26122}" srcOrd="1" destOrd="0" presId="urn:microsoft.com/office/officeart/2005/8/layout/process1"/>
    <dgm:cxn modelId="{2238A832-47DE-41A5-93E8-22B3E3DD17A6}" type="presOf" srcId="{95ECC4C7-6AC0-429A-AEC5-D0DA3EBFE0B9}" destId="{30F38EDA-4DBF-41E1-AFE8-03F899F7E4A6}" srcOrd="1" destOrd="0" presId="urn:microsoft.com/office/officeart/2005/8/layout/process1"/>
    <dgm:cxn modelId="{2C7E7138-25A5-4217-AD6E-503474A2AC59}" srcId="{CF07AAE6-122F-4AD6-90CC-BDBCDC331755}" destId="{7045E4F2-72E6-450B-8DE7-598E5D7E4594}" srcOrd="1" destOrd="0" parTransId="{1DA3073F-B1AC-4E55-B1D3-EFE2AAFDFD2F}" sibTransId="{F116878C-F31D-478B-9F77-16D7C00AC1F9}"/>
    <dgm:cxn modelId="{1F81B368-1390-440F-9AFE-6423C1398217}" type="presOf" srcId="{DD83FD64-FD53-4F09-9D39-6FE26D4990D2}" destId="{851CF157-95EC-4DDC-9F72-3244BF8B357A}" srcOrd="0" destOrd="0" presId="urn:microsoft.com/office/officeart/2005/8/layout/process1"/>
    <dgm:cxn modelId="{CAB2D949-C447-45FA-94A6-13AB49C4B95E}" srcId="{CF07AAE6-122F-4AD6-90CC-BDBCDC331755}" destId="{DD83FD64-FD53-4F09-9D39-6FE26D4990D2}" srcOrd="3" destOrd="0" parTransId="{4D8037E1-1C75-40FD-AFE8-942ED90BD0A8}" sibTransId="{0D2E2804-FD8D-4D74-89AD-E7D1CABE3B57}"/>
    <dgm:cxn modelId="{36F3D953-4EC7-4CA3-BEB8-B60287AA704C}" type="presOf" srcId="{F116878C-F31D-478B-9F77-16D7C00AC1F9}" destId="{4070EE5B-9ED8-4397-A618-526423166C08}" srcOrd="1" destOrd="0" presId="urn:microsoft.com/office/officeart/2005/8/layout/process1"/>
    <dgm:cxn modelId="{FBDBC058-8642-4F8A-B820-EACB8628D63B}" type="presOf" srcId="{6318386F-9E96-40DA-8D98-407E11F42F4A}" destId="{80B437F7-B408-4317-B58D-D788B0F1D79B}" srcOrd="0" destOrd="0" presId="urn:microsoft.com/office/officeart/2005/8/layout/process1"/>
    <dgm:cxn modelId="{3E2DAE59-20DA-4D93-8386-72D644911BBD}" type="presOf" srcId="{1BEA45E0-89BB-481D-A983-D4B6D90D90A4}" destId="{17FCE802-51CE-435D-BE7E-10EBFFCD3809}" srcOrd="0" destOrd="0" presId="urn:microsoft.com/office/officeart/2005/8/layout/process1"/>
    <dgm:cxn modelId="{A4DB6F83-B834-4E0E-9A4E-D7E771B74CE5}" type="presOf" srcId="{7045E4F2-72E6-450B-8DE7-598E5D7E4594}" destId="{56162AD2-B567-454C-AB3C-001077BCAF23}" srcOrd="0" destOrd="0" presId="urn:microsoft.com/office/officeart/2005/8/layout/process1"/>
    <dgm:cxn modelId="{A6647C8C-18AE-48CE-8154-E08E9E7762ED}" srcId="{CF07AAE6-122F-4AD6-90CC-BDBCDC331755}" destId="{705DA90C-267D-4D59-8961-F8B26A858496}" srcOrd="0" destOrd="0" parTransId="{5CA0673E-3FC5-411B-B375-62298329E15B}" sibTransId="{1BEA45E0-89BB-481D-A983-D4B6D90D90A4}"/>
    <dgm:cxn modelId="{652860A0-E3AA-44A5-9504-0C1A0230F573}" type="presOf" srcId="{F116878C-F31D-478B-9F77-16D7C00AC1F9}" destId="{BCC09537-3A97-4B53-8182-E47C506C141F}" srcOrd="0" destOrd="0" presId="urn:microsoft.com/office/officeart/2005/8/layout/process1"/>
    <dgm:cxn modelId="{F8B81ABC-B989-4372-872C-081667761410}" type="presOf" srcId="{95ECC4C7-6AC0-429A-AEC5-D0DA3EBFE0B9}" destId="{625E2593-CC1B-403C-B38C-61E1EE1AF309}" srcOrd="0" destOrd="0" presId="urn:microsoft.com/office/officeart/2005/8/layout/process1"/>
    <dgm:cxn modelId="{2079C9C1-0508-46CB-93E3-3530C4B2160E}" type="presOf" srcId="{0D2E2804-FD8D-4D74-89AD-E7D1CABE3B57}" destId="{F9FB68F0-8037-4290-8075-26F650EABDB9}" srcOrd="1" destOrd="0" presId="urn:microsoft.com/office/officeart/2005/8/layout/process1"/>
    <dgm:cxn modelId="{A7DAC6C9-AF78-4274-BC5E-5F638AD2C5D1}" srcId="{CF07AAE6-122F-4AD6-90CC-BDBCDC331755}" destId="{1A26A498-D97C-49EF-8F4E-A6A2FFA833E2}" srcOrd="4" destOrd="0" parTransId="{98980F17-6CF5-4CFA-B416-0215B511AE16}" sibTransId="{BF2B0CE0-3F73-4158-861B-CAA6F767EC0F}"/>
    <dgm:cxn modelId="{21CD7CDB-E833-408D-B0B4-07A6C1A8A003}" type="presOf" srcId="{1A26A498-D97C-49EF-8F4E-A6A2FFA833E2}" destId="{92ABC293-A27F-4B09-9E54-5D0C99DB020E}" srcOrd="0" destOrd="0" presId="urn:microsoft.com/office/officeart/2005/8/layout/process1"/>
    <dgm:cxn modelId="{AB4424FA-F13E-4C16-A094-28D3A01FE3D3}" type="presOf" srcId="{0D2E2804-FD8D-4D74-89AD-E7D1CABE3B57}" destId="{332B608F-EC63-49AE-A360-E6CEF6967F11}" srcOrd="0" destOrd="0" presId="urn:microsoft.com/office/officeart/2005/8/layout/process1"/>
    <dgm:cxn modelId="{7AE604FB-EDFF-4400-BF59-3FAE2DE10341}" type="presOf" srcId="{CF07AAE6-122F-4AD6-90CC-BDBCDC331755}" destId="{3D1E8515-5E79-4693-978E-9DD5E43EDFAE}" srcOrd="0" destOrd="0" presId="urn:microsoft.com/office/officeart/2005/8/layout/process1"/>
    <dgm:cxn modelId="{ADC81BCB-433E-4954-A68F-FBEEF2CF371E}" type="presParOf" srcId="{3D1E8515-5E79-4693-978E-9DD5E43EDFAE}" destId="{F98B9AFC-39E9-4CDC-9292-6EDB4D4E4403}" srcOrd="0" destOrd="0" presId="urn:microsoft.com/office/officeart/2005/8/layout/process1"/>
    <dgm:cxn modelId="{16B60362-EB8D-463D-BF9E-6ABC2CAC078B}" type="presParOf" srcId="{3D1E8515-5E79-4693-978E-9DD5E43EDFAE}" destId="{17FCE802-51CE-435D-BE7E-10EBFFCD3809}" srcOrd="1" destOrd="0" presId="urn:microsoft.com/office/officeart/2005/8/layout/process1"/>
    <dgm:cxn modelId="{72B9806A-DC54-41B9-AC7B-3DE1C5048865}" type="presParOf" srcId="{17FCE802-51CE-435D-BE7E-10EBFFCD3809}" destId="{0626D2F3-D392-41C8-B3FE-0857B8A26122}" srcOrd="0" destOrd="0" presId="urn:microsoft.com/office/officeart/2005/8/layout/process1"/>
    <dgm:cxn modelId="{DCDD6FFE-46FF-45DD-BCBF-F311EC514939}" type="presParOf" srcId="{3D1E8515-5E79-4693-978E-9DD5E43EDFAE}" destId="{56162AD2-B567-454C-AB3C-001077BCAF23}" srcOrd="2" destOrd="0" presId="urn:microsoft.com/office/officeart/2005/8/layout/process1"/>
    <dgm:cxn modelId="{7A4A28CA-ABF5-4ED9-B693-26E8117690B3}" type="presParOf" srcId="{3D1E8515-5E79-4693-978E-9DD5E43EDFAE}" destId="{BCC09537-3A97-4B53-8182-E47C506C141F}" srcOrd="3" destOrd="0" presId="urn:microsoft.com/office/officeart/2005/8/layout/process1"/>
    <dgm:cxn modelId="{03A240EC-C900-4057-B02E-E964D5B5A59A}" type="presParOf" srcId="{BCC09537-3A97-4B53-8182-E47C506C141F}" destId="{4070EE5B-9ED8-4397-A618-526423166C08}" srcOrd="0" destOrd="0" presId="urn:microsoft.com/office/officeart/2005/8/layout/process1"/>
    <dgm:cxn modelId="{A33B9851-2078-4CD9-838F-BB43D572AED9}" type="presParOf" srcId="{3D1E8515-5E79-4693-978E-9DD5E43EDFAE}" destId="{80B437F7-B408-4317-B58D-D788B0F1D79B}" srcOrd="4" destOrd="0" presId="urn:microsoft.com/office/officeart/2005/8/layout/process1"/>
    <dgm:cxn modelId="{8E46DC6F-E9BB-4E29-9822-960FB706CE2E}" type="presParOf" srcId="{3D1E8515-5E79-4693-978E-9DD5E43EDFAE}" destId="{625E2593-CC1B-403C-B38C-61E1EE1AF309}" srcOrd="5" destOrd="0" presId="urn:microsoft.com/office/officeart/2005/8/layout/process1"/>
    <dgm:cxn modelId="{132F4CBB-F3DE-4BC9-BC90-3DC48E9E3AE4}" type="presParOf" srcId="{625E2593-CC1B-403C-B38C-61E1EE1AF309}" destId="{30F38EDA-4DBF-41E1-AFE8-03F899F7E4A6}" srcOrd="0" destOrd="0" presId="urn:microsoft.com/office/officeart/2005/8/layout/process1"/>
    <dgm:cxn modelId="{89535201-48FC-4583-9B47-82CA39D5AAF2}" type="presParOf" srcId="{3D1E8515-5E79-4693-978E-9DD5E43EDFAE}" destId="{851CF157-95EC-4DDC-9F72-3244BF8B357A}" srcOrd="6" destOrd="0" presId="urn:microsoft.com/office/officeart/2005/8/layout/process1"/>
    <dgm:cxn modelId="{C8FC06ED-1650-4B1C-8C6C-B624940CC698}" type="presParOf" srcId="{3D1E8515-5E79-4693-978E-9DD5E43EDFAE}" destId="{332B608F-EC63-49AE-A360-E6CEF6967F11}" srcOrd="7" destOrd="0" presId="urn:microsoft.com/office/officeart/2005/8/layout/process1"/>
    <dgm:cxn modelId="{0B49A46E-A99B-47DB-A61A-28CF2C0FF057}" type="presParOf" srcId="{332B608F-EC63-49AE-A360-E6CEF6967F11}" destId="{F9FB68F0-8037-4290-8075-26F650EABDB9}" srcOrd="0" destOrd="0" presId="urn:microsoft.com/office/officeart/2005/8/layout/process1"/>
    <dgm:cxn modelId="{BB62F8A9-171B-4D28-972F-FEBC0D6423AD}" type="presParOf" srcId="{3D1E8515-5E79-4693-978E-9DD5E43EDFAE}" destId="{92ABC293-A27F-4B09-9E54-5D0C99DB020E}" srcOrd="8" destOrd="0" presId="urn:microsoft.com/office/officeart/2005/8/layout/process1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  <a:ext uri="{C62137D5-CB1D-491B-B009-E17868A290BF}">
      <dgm14:recolorImg xmlns:dgm14="http://schemas.microsoft.com/office/drawing/2010/diagram" val="1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F98B9AFC-39E9-4CDC-9292-6EDB4D4E4403}">
      <dsp:nvSpPr>
        <dsp:cNvPr id="0" name=""/>
        <dsp:cNvSpPr/>
      </dsp:nvSpPr>
      <dsp:spPr>
        <a:xfrm>
          <a:off x="2976" y="1755179"/>
          <a:ext cx="922734" cy="553640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/>
            <a:t>Predisposing Factors</a:t>
          </a:r>
        </a:p>
      </dsp:txBody>
      <dsp:txXfrm>
        <a:off x="19192" y="1771395"/>
        <a:ext cx="890302" cy="521208"/>
      </dsp:txXfrm>
    </dsp:sp>
    <dsp:sp modelId="{17FCE802-51CE-435D-BE7E-10EBFFCD3809}">
      <dsp:nvSpPr>
        <dsp:cNvPr id="0" name=""/>
        <dsp:cNvSpPr/>
      </dsp:nvSpPr>
      <dsp:spPr>
        <a:xfrm>
          <a:off x="1017984" y="1917580"/>
          <a:ext cx="195619" cy="228838"/>
        </a:xfrm>
        <a:prstGeom prst="rightArrow">
          <a:avLst>
            <a:gd name="adj1" fmla="val 60000"/>
            <a:gd name="adj2" fmla="val 50000"/>
          </a:avLst>
        </a:prstGeom>
        <a:solidFill>
          <a:schemeClr val="dk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900" kern="1200"/>
        </a:p>
      </dsp:txBody>
      <dsp:txXfrm>
        <a:off x="1017984" y="1963348"/>
        <a:ext cx="136933" cy="137302"/>
      </dsp:txXfrm>
    </dsp:sp>
    <dsp:sp modelId="{56162AD2-B567-454C-AB3C-001077BCAF23}">
      <dsp:nvSpPr>
        <dsp:cNvPr id="0" name=""/>
        <dsp:cNvSpPr/>
      </dsp:nvSpPr>
      <dsp:spPr>
        <a:xfrm>
          <a:off x="1294804" y="1755179"/>
          <a:ext cx="922734" cy="553640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/>
            <a:t>Enabling Resources</a:t>
          </a:r>
        </a:p>
      </dsp:txBody>
      <dsp:txXfrm>
        <a:off x="1311020" y="1771395"/>
        <a:ext cx="890302" cy="521208"/>
      </dsp:txXfrm>
    </dsp:sp>
    <dsp:sp modelId="{BCC09537-3A97-4B53-8182-E47C506C141F}">
      <dsp:nvSpPr>
        <dsp:cNvPr id="0" name=""/>
        <dsp:cNvSpPr/>
      </dsp:nvSpPr>
      <dsp:spPr>
        <a:xfrm>
          <a:off x="2309812" y="1917580"/>
          <a:ext cx="195619" cy="228838"/>
        </a:xfrm>
        <a:prstGeom prst="rightArrow">
          <a:avLst>
            <a:gd name="adj1" fmla="val 60000"/>
            <a:gd name="adj2" fmla="val 50000"/>
          </a:avLst>
        </a:prstGeom>
        <a:solidFill>
          <a:schemeClr val="dk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900" kern="1200"/>
        </a:p>
      </dsp:txBody>
      <dsp:txXfrm>
        <a:off x="2309812" y="1963348"/>
        <a:ext cx="136933" cy="137302"/>
      </dsp:txXfrm>
    </dsp:sp>
    <dsp:sp modelId="{80B437F7-B408-4317-B58D-D788B0F1D79B}">
      <dsp:nvSpPr>
        <dsp:cNvPr id="0" name=""/>
        <dsp:cNvSpPr/>
      </dsp:nvSpPr>
      <dsp:spPr>
        <a:xfrm>
          <a:off x="2586632" y="1755179"/>
          <a:ext cx="922734" cy="553640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/>
            <a:t>Need Factors</a:t>
          </a:r>
        </a:p>
      </dsp:txBody>
      <dsp:txXfrm>
        <a:off x="2602848" y="1771395"/>
        <a:ext cx="890302" cy="521208"/>
      </dsp:txXfrm>
    </dsp:sp>
    <dsp:sp modelId="{625E2593-CC1B-403C-B38C-61E1EE1AF309}">
      <dsp:nvSpPr>
        <dsp:cNvPr id="0" name=""/>
        <dsp:cNvSpPr/>
      </dsp:nvSpPr>
      <dsp:spPr>
        <a:xfrm>
          <a:off x="3601640" y="1917580"/>
          <a:ext cx="195619" cy="228838"/>
        </a:xfrm>
        <a:prstGeom prst="rightArrow">
          <a:avLst>
            <a:gd name="adj1" fmla="val 60000"/>
            <a:gd name="adj2" fmla="val 50000"/>
          </a:avLst>
        </a:prstGeom>
        <a:solidFill>
          <a:schemeClr val="dk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900" kern="1200"/>
        </a:p>
      </dsp:txBody>
      <dsp:txXfrm>
        <a:off x="3601640" y="1963348"/>
        <a:ext cx="136933" cy="137302"/>
      </dsp:txXfrm>
    </dsp:sp>
    <dsp:sp modelId="{851CF157-95EC-4DDC-9F72-3244BF8B357A}">
      <dsp:nvSpPr>
        <dsp:cNvPr id="0" name=""/>
        <dsp:cNvSpPr/>
      </dsp:nvSpPr>
      <dsp:spPr>
        <a:xfrm>
          <a:off x="3878460" y="1755179"/>
          <a:ext cx="922734" cy="553640"/>
        </a:xfrm>
        <a:prstGeom prst="roundRect">
          <a:avLst>
            <a:gd name="adj" fmla="val 10000"/>
          </a:avLst>
        </a:prstGeom>
        <a:solidFill>
          <a:schemeClr val="tx1"/>
        </a:solidFill>
        <a:ln w="254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>
              <a:solidFill>
                <a:schemeClr val="bg1"/>
              </a:solidFill>
            </a:rPr>
            <a:t>Housing</a:t>
          </a:r>
        </a:p>
      </dsp:txBody>
      <dsp:txXfrm>
        <a:off x="3894676" y="1771395"/>
        <a:ext cx="890302" cy="521208"/>
      </dsp:txXfrm>
    </dsp:sp>
    <dsp:sp modelId="{332B608F-EC63-49AE-A360-E6CEF6967F11}">
      <dsp:nvSpPr>
        <dsp:cNvPr id="0" name=""/>
        <dsp:cNvSpPr/>
      </dsp:nvSpPr>
      <dsp:spPr>
        <a:xfrm>
          <a:off x="4893468" y="1917580"/>
          <a:ext cx="195619" cy="228838"/>
        </a:xfrm>
        <a:prstGeom prst="rightArrow">
          <a:avLst>
            <a:gd name="adj1" fmla="val 60000"/>
            <a:gd name="adj2" fmla="val 50000"/>
          </a:avLst>
        </a:prstGeom>
        <a:solidFill>
          <a:schemeClr val="dk1">
            <a:tint val="60000"/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0" tIns="0" rIns="0" bIns="0" numCol="1" spcCol="1270" anchor="ctr" anchorCtr="0">
          <a:noAutofit/>
        </a:bodyPr>
        <a:lstStyle/>
        <a:p>
          <a:pPr marL="0" lvl="0" indent="0" algn="ctr" defTabSz="4000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900" kern="1200"/>
        </a:p>
      </dsp:txBody>
      <dsp:txXfrm>
        <a:off x="4893468" y="1963348"/>
        <a:ext cx="136933" cy="137302"/>
      </dsp:txXfrm>
    </dsp:sp>
    <dsp:sp modelId="{92ABC293-A27F-4B09-9E54-5D0C99DB020E}">
      <dsp:nvSpPr>
        <dsp:cNvPr id="0" name=""/>
        <dsp:cNvSpPr/>
      </dsp:nvSpPr>
      <dsp:spPr>
        <a:xfrm>
          <a:off x="5170289" y="1755179"/>
          <a:ext cx="922734" cy="553640"/>
        </a:xfrm>
        <a:prstGeom prst="roundRect">
          <a:avLst>
            <a:gd name="adj" fmla="val 10000"/>
          </a:avLst>
        </a:prstGeom>
        <a:solidFill>
          <a:schemeClr val="lt1">
            <a:hueOff val="0"/>
            <a:satOff val="0"/>
            <a:lumOff val="0"/>
            <a:alphaOff val="0"/>
          </a:schemeClr>
        </a:solidFill>
        <a:ln w="25400" cap="flat" cmpd="sng" algn="ctr">
          <a:solidFill>
            <a:schemeClr val="dk1">
              <a:shade val="80000"/>
              <a:hueOff val="0"/>
              <a:satOff val="0"/>
              <a:lumOff val="0"/>
              <a:alphaOff val="0"/>
            </a:schemeClr>
          </a:solidFill>
          <a:prstDash val="solid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41910" tIns="41910" rIns="41910" bIns="41910" numCol="1" spcCol="1270" anchor="ctr" anchorCtr="0">
          <a:noAutofit/>
        </a:bodyPr>
        <a:lstStyle/>
        <a:p>
          <a:pPr marL="0" lvl="0" indent="0" algn="ctr" defTabSz="4889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100" kern="1200" dirty="0"/>
            <a:t>Health Outcomes</a:t>
          </a:r>
        </a:p>
      </dsp:txBody>
      <dsp:txXfrm>
        <a:off x="5186505" y="1771395"/>
        <a:ext cx="890302" cy="521208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process1">
  <dgm:title val=""/>
  <dgm:desc val=""/>
  <dgm:catLst>
    <dgm:cat type="process" pri="1000"/>
    <dgm:cat type="convert" pri="15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Name0">
    <dgm:varLst>
      <dgm:dir/>
      <dgm:resizeHandles val="exact"/>
    </dgm:varLst>
    <dgm:choose name="Name1">
      <dgm:if name="Name2" func="var" arg="dir" op="equ" val="norm">
        <dgm:alg type="lin"/>
      </dgm:if>
      <dgm:else name="Name3">
        <dgm:alg type="lin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ch" ptType="node" refType="w"/>
      <dgm:constr type="h" for="ch" ptType="node" op="equ"/>
      <dgm:constr type="primFontSz" for="ch" ptType="node" op="equ" val="65"/>
      <dgm:constr type="w" for="ch" ptType="sibTrans" refType="w" refFor="ch" refPtType="node" op="equ" fact="0.4"/>
      <dgm:constr type="h" for="ch" ptType="sibTrans" op="equ"/>
      <dgm:constr type="primFontSz" for="des" forName="connectorText" op="equ" val="55"/>
      <dgm:constr type="primFontSz" for="des" forName="connectorText" refType="primFontSz" refFor="ch" refPtType="node" op="lte" fact="0.8"/>
    </dgm:constrLst>
    <dgm:ruleLst/>
    <dgm:forEach name="nodesForEach" axis="ch" ptType="node">
      <dgm:layoutNode name="node">
        <dgm:varLst>
          <dgm:bulletEnabled val="1"/>
        </dgm:varLst>
        <dgm:alg type="tx"/>
        <dgm:shape xmlns:r="http://schemas.openxmlformats.org/officeDocument/2006/relationships" type="roundRect" r:blip="">
          <dgm:adjLst>
            <dgm:adj idx="1" val="0.1"/>
          </dgm:adjLst>
        </dgm:shape>
        <dgm:presOf axis="desOrSelf" ptType="node"/>
        <dgm:constrLst>
          <dgm:constr type="h" refType="w" fact="0.6"/>
          <dgm:constr type="tMarg" refType="primFontSz" fact="0.3"/>
          <dgm:constr type="bMarg" refType="primFontSz" fact="0.3"/>
          <dgm:constr type="lMarg" refType="primFontSz" fact="0.3"/>
          <dgm:constr type="rMarg" refType="primFontSz" fact="0.3"/>
        </dgm:constrLst>
        <dgm:ruleLst>
          <dgm:rule type="primFontSz" val="18" fact="NaN" max="NaN"/>
          <dgm:rule type="h" val="NaN" fact="1.5" max="NaN"/>
          <dgm:rule type="primFontSz" val="5" fact="NaN" max="NaN"/>
          <dgm:rule type="h" val="INF" fact="NaN" max="NaN"/>
        </dgm:ruleLst>
      </dgm:layoutNode>
      <dgm:forEach name="sibTransForEach" axis="followSib" ptType="sibTrans" cnt="1">
        <dgm:layoutNode name="sibTrans">
          <dgm:alg type="conn">
            <dgm:param type="begPts" val="auto"/>
            <dgm:param type="endPts" val="auto"/>
          </dgm:alg>
          <dgm:shape xmlns:r="http://schemas.openxmlformats.org/officeDocument/2006/relationships" type="conn" r:blip="">
            <dgm:adjLst/>
          </dgm:shape>
          <dgm:presOf axis="self"/>
          <dgm:constrLst>
            <dgm:constr type="h" refType="w" fact="0.62"/>
            <dgm:constr type="connDist"/>
            <dgm:constr type="begPad" refType="connDist" fact="0.25"/>
            <dgm:constr type="endPad" refType="connDist" fact="0.22"/>
          </dgm:constrLst>
          <dgm:ruleLst/>
          <dgm:layoutNode name="connectorText">
            <dgm:alg type="tx">
              <dgm:param type="autoTxRot" val="grav"/>
            </dgm:alg>
            <dgm:shape xmlns:r="http://schemas.openxmlformats.org/officeDocument/2006/relationships" type="conn" r:blip="" hideGeom="1">
              <dgm:adjLst/>
            </dgm:shape>
            <dgm:presOf axis="self"/>
            <dgm:constrLst>
              <dgm:constr type="lMarg"/>
              <dgm:constr type="rMarg"/>
              <dgm:constr type="tMarg"/>
              <dgm:constr type="bMarg"/>
            </dgm:constrLst>
            <dgm:ruleLst>
              <dgm:rule type="primFontSz" val="5" fact="NaN" max="NaN"/>
            </dgm:ruleLst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FDE54-48DC-434B-91A8-880F0E2CC469}" type="datetimeFigureOut">
              <a:rPr lang="en-US" smtClean="0"/>
              <a:pPr/>
              <a:t>1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418F2-A49C-4948-8724-3C01734EB7F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FDE54-48DC-434B-91A8-880F0E2CC469}" type="datetimeFigureOut">
              <a:rPr lang="en-US" smtClean="0"/>
              <a:pPr/>
              <a:t>1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418F2-A49C-4948-8724-3C01734EB7F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FDE54-48DC-434B-91A8-880F0E2CC469}" type="datetimeFigureOut">
              <a:rPr lang="en-US" smtClean="0"/>
              <a:pPr/>
              <a:t>1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418F2-A49C-4948-8724-3C01734EB7F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FDE54-48DC-434B-91A8-880F0E2CC469}" type="datetimeFigureOut">
              <a:rPr lang="en-US" smtClean="0"/>
              <a:pPr/>
              <a:t>1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418F2-A49C-4948-8724-3C01734EB7F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FDE54-48DC-434B-91A8-880F0E2CC469}" type="datetimeFigureOut">
              <a:rPr lang="en-US" smtClean="0"/>
              <a:pPr/>
              <a:t>1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418F2-A49C-4948-8724-3C01734EB7F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FDE54-48DC-434B-91A8-880F0E2CC469}" type="datetimeFigureOut">
              <a:rPr lang="en-US" smtClean="0"/>
              <a:pPr/>
              <a:t>1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418F2-A49C-4948-8724-3C01734EB7F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FDE54-48DC-434B-91A8-880F0E2CC469}" type="datetimeFigureOut">
              <a:rPr lang="en-US" smtClean="0"/>
              <a:pPr/>
              <a:t>1/1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418F2-A49C-4948-8724-3C01734EB7F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FDE54-48DC-434B-91A8-880F0E2CC469}" type="datetimeFigureOut">
              <a:rPr lang="en-US" smtClean="0"/>
              <a:pPr/>
              <a:t>1/1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418F2-A49C-4948-8724-3C01734EB7F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FDE54-48DC-434B-91A8-880F0E2CC469}" type="datetimeFigureOut">
              <a:rPr lang="en-US" smtClean="0"/>
              <a:pPr/>
              <a:t>1/1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418F2-A49C-4948-8724-3C01734EB7F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FDE54-48DC-434B-91A8-880F0E2CC469}" type="datetimeFigureOut">
              <a:rPr lang="en-US" smtClean="0"/>
              <a:pPr/>
              <a:t>1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418F2-A49C-4948-8724-3C01734EB7F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DFDE54-48DC-434B-91A8-880F0E2CC469}" type="datetimeFigureOut">
              <a:rPr lang="en-US" smtClean="0"/>
              <a:pPr/>
              <a:t>1/1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47418F2-A49C-4948-8724-3C01734EB7FD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DFDE54-48DC-434B-91A8-880F0E2CC469}" type="datetimeFigureOut">
              <a:rPr lang="en-US" smtClean="0"/>
              <a:pPr/>
              <a:t>1/1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7418F2-A49C-4948-8724-3C01734EB7FD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1.xml"/><Relationship Id="rId2" Type="http://schemas.openxmlformats.org/officeDocument/2006/relationships/diagramData" Target="../diagrams/data1.xml"/><Relationship Id="rId1" Type="http://schemas.openxmlformats.org/officeDocument/2006/relationships/slideLayout" Target="../slideLayouts/slideLayout7.xml"/><Relationship Id="rId6" Type="http://schemas.microsoft.com/office/2007/relationships/diagramDrawing" Target="../diagrams/drawing1.xml"/><Relationship Id="rId5" Type="http://schemas.openxmlformats.org/officeDocument/2006/relationships/diagramColors" Target="../diagrams/colors1.xml"/><Relationship Id="rId4" Type="http://schemas.openxmlformats.org/officeDocument/2006/relationships/diagramQuickStyle" Target="../diagrams/quickStyl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Diagram 1"/>
          <p:cNvGraphicFramePr/>
          <p:nvPr>
            <p:extLst>
              <p:ext uri="{D42A27DB-BD31-4B8C-83A1-F6EECF244321}">
                <p14:modId xmlns:p14="http://schemas.microsoft.com/office/powerpoint/2010/main" val="834218543"/>
              </p:ext>
            </p:extLst>
          </p:nvPr>
        </p:nvGraphicFramePr>
        <p:xfrm>
          <a:off x="1524000" y="1397000"/>
          <a:ext cx="6096000" cy="406400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  <p:cxnSp>
        <p:nvCxnSpPr>
          <p:cNvPr id="6" name="Straight Arrow Connector 5"/>
          <p:cNvCxnSpPr/>
          <p:nvPr/>
        </p:nvCxnSpPr>
        <p:spPr>
          <a:xfrm flipH="1" flipV="1">
            <a:off x="1952625" y="3714749"/>
            <a:ext cx="9525" cy="52387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7" name="Straight Arrow Connector 6"/>
          <p:cNvCxnSpPr/>
          <p:nvPr/>
        </p:nvCxnSpPr>
        <p:spPr>
          <a:xfrm flipH="1" flipV="1">
            <a:off x="3295650" y="3714750"/>
            <a:ext cx="9525" cy="52387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8" name="Straight Arrow Connector 7"/>
          <p:cNvCxnSpPr/>
          <p:nvPr/>
        </p:nvCxnSpPr>
        <p:spPr>
          <a:xfrm flipH="1" flipV="1">
            <a:off x="4591050" y="3714750"/>
            <a:ext cx="9525" cy="52387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/>
          <p:nvPr/>
        </p:nvCxnSpPr>
        <p:spPr>
          <a:xfrm flipH="1" flipV="1">
            <a:off x="5924550" y="3714750"/>
            <a:ext cx="9525" cy="523875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>
            <a:off x="1962150" y="4238624"/>
            <a:ext cx="5362575" cy="1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>
            <a:off x="7324725" y="3714750"/>
            <a:ext cx="0" cy="523875"/>
          </a:xfrm>
          <a:prstGeom prst="line">
            <a:avLst/>
          </a:prstGeom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524000" y="4378325"/>
            <a:ext cx="1013460" cy="2400657"/>
          </a:xfrm>
          <a:prstGeom prst="rect">
            <a:avLst/>
          </a:prstGeom>
          <a:noFill/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</p:spPr>
        <p:txBody>
          <a:bodyPr wrap="square" rtlCol="0">
            <a:spAutoFit/>
          </a:bodyPr>
          <a:lstStyle/>
          <a:p>
            <a:r>
              <a:rPr lang="en-US" sz="1000" dirty="0"/>
              <a:t>Age</a:t>
            </a:r>
          </a:p>
          <a:p>
            <a:r>
              <a:rPr lang="en-US" sz="1000" dirty="0"/>
              <a:t>Gender</a:t>
            </a:r>
          </a:p>
          <a:p>
            <a:r>
              <a:rPr lang="en-US" sz="1000" dirty="0"/>
              <a:t>Race</a:t>
            </a:r>
          </a:p>
          <a:p>
            <a:r>
              <a:rPr lang="en-US" sz="1000" dirty="0"/>
              <a:t>Education</a:t>
            </a:r>
          </a:p>
          <a:p>
            <a:r>
              <a:rPr lang="en-US" sz="1000" dirty="0"/>
              <a:t>Employment</a:t>
            </a:r>
          </a:p>
          <a:p>
            <a:r>
              <a:rPr lang="en-US" sz="1000" dirty="0"/>
              <a:t>Relationship status</a:t>
            </a:r>
          </a:p>
          <a:p>
            <a:r>
              <a:rPr lang="en-US" sz="1000" dirty="0"/>
              <a:t>Sex work</a:t>
            </a:r>
          </a:p>
          <a:p>
            <a:r>
              <a:rPr lang="en-US" sz="1000" dirty="0"/>
              <a:t>CJ-involvement</a:t>
            </a:r>
          </a:p>
          <a:p>
            <a:r>
              <a:rPr lang="en-US" sz="1000" dirty="0">
                <a:solidFill>
                  <a:srgbClr val="FF0000"/>
                </a:solidFill>
              </a:rPr>
              <a:t>Housing status</a:t>
            </a:r>
          </a:p>
          <a:p>
            <a:r>
              <a:rPr lang="en-US" sz="1000" dirty="0">
                <a:solidFill>
                  <a:srgbClr val="FF0000"/>
                </a:solidFill>
              </a:rPr>
              <a:t>Psychiatric disorders</a:t>
            </a:r>
          </a:p>
          <a:p>
            <a:r>
              <a:rPr lang="en-US" sz="1000" dirty="0">
                <a:solidFill>
                  <a:srgbClr val="FF0000"/>
                </a:solidFill>
              </a:rPr>
              <a:t>Substance use disorder</a:t>
            </a:r>
          </a:p>
          <a:p>
            <a:endParaRPr lang="en-US" sz="1000" dirty="0"/>
          </a:p>
        </p:txBody>
      </p:sp>
      <p:sp>
        <p:nvSpPr>
          <p:cNvPr id="15" name="TextBox 14"/>
          <p:cNvSpPr txBox="1"/>
          <p:nvPr/>
        </p:nvSpPr>
        <p:spPr>
          <a:xfrm>
            <a:off x="2820035" y="4378325"/>
            <a:ext cx="1156741" cy="2246769"/>
          </a:xfrm>
          <a:prstGeom prst="rect">
            <a:avLst/>
          </a:prstGeom>
          <a:noFill/>
          <a:ln w="9525" cmpd="sng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/>
              <a:t>Health Insurance</a:t>
            </a:r>
          </a:p>
          <a:p>
            <a:endParaRPr lang="en-US" sz="1000" dirty="0"/>
          </a:p>
          <a:p>
            <a:r>
              <a:rPr lang="en-US" sz="1000" b="1" dirty="0">
                <a:solidFill>
                  <a:srgbClr val="FF0000"/>
                </a:solidFill>
              </a:rPr>
              <a:t>CHANGE Initiative</a:t>
            </a:r>
          </a:p>
          <a:p>
            <a:r>
              <a:rPr lang="en-US" sz="1000" dirty="0">
                <a:solidFill>
                  <a:srgbClr val="FF0000"/>
                </a:solidFill>
              </a:rPr>
              <a:t>Intensive CM</a:t>
            </a:r>
          </a:p>
          <a:p>
            <a:r>
              <a:rPr lang="en-US" sz="1000" dirty="0">
                <a:solidFill>
                  <a:srgbClr val="FF0000"/>
                </a:solidFill>
              </a:rPr>
              <a:t>Housing assistance</a:t>
            </a:r>
          </a:p>
          <a:p>
            <a:r>
              <a:rPr lang="en-US" sz="1000" dirty="0">
                <a:solidFill>
                  <a:srgbClr val="FF0000"/>
                </a:solidFill>
              </a:rPr>
              <a:t>Network liaisons</a:t>
            </a:r>
          </a:p>
          <a:p>
            <a:r>
              <a:rPr lang="en-US" sz="1000" dirty="0">
                <a:solidFill>
                  <a:srgbClr val="FF0000"/>
                </a:solidFill>
              </a:rPr>
              <a:t>Vocational CM</a:t>
            </a:r>
          </a:p>
          <a:p>
            <a:r>
              <a:rPr lang="en-US" sz="1000" dirty="0">
                <a:solidFill>
                  <a:srgbClr val="FF0000"/>
                </a:solidFill>
              </a:rPr>
              <a:t>Treatment for substance use disorders</a:t>
            </a:r>
          </a:p>
          <a:p>
            <a:r>
              <a:rPr lang="en-US" sz="1000" dirty="0">
                <a:solidFill>
                  <a:srgbClr val="FF0000"/>
                </a:solidFill>
              </a:rPr>
              <a:t>Treatment for </a:t>
            </a:r>
            <a:r>
              <a:rPr lang="en-US" sz="1000">
                <a:solidFill>
                  <a:srgbClr val="FF0000"/>
                </a:solidFill>
              </a:rPr>
              <a:t>medical and psychiatric </a:t>
            </a:r>
            <a:r>
              <a:rPr lang="en-US" sz="1000" dirty="0">
                <a:solidFill>
                  <a:srgbClr val="FF0000"/>
                </a:solidFill>
              </a:rPr>
              <a:t>comorbidity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4160837" y="4384675"/>
            <a:ext cx="965200" cy="1477328"/>
          </a:xfrm>
          <a:prstGeom prst="rect">
            <a:avLst/>
          </a:prstGeom>
          <a:noFill/>
          <a:ln w="9525" cmpd="sng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/>
              <a:t>Medical          comorbidity</a:t>
            </a:r>
          </a:p>
          <a:p>
            <a:r>
              <a:rPr lang="en-US" sz="1000" dirty="0"/>
              <a:t>Drug use severity</a:t>
            </a:r>
          </a:p>
          <a:p>
            <a:r>
              <a:rPr lang="en-US" sz="1000" dirty="0"/>
              <a:t>Psychiatric severity</a:t>
            </a:r>
          </a:p>
          <a:p>
            <a:r>
              <a:rPr lang="en-US" sz="1000" dirty="0"/>
              <a:t>Sex work</a:t>
            </a:r>
          </a:p>
          <a:p>
            <a:r>
              <a:rPr lang="en-US" sz="1000" dirty="0"/>
              <a:t>CJ-involvement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5445125" y="4378325"/>
            <a:ext cx="977900" cy="553998"/>
          </a:xfrm>
          <a:prstGeom prst="rect">
            <a:avLst/>
          </a:prstGeom>
          <a:noFill/>
          <a:ln w="9525" cmpd="sng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/>
              <a:t>Homeless</a:t>
            </a:r>
          </a:p>
          <a:p>
            <a:r>
              <a:rPr lang="en-US" sz="1000" dirty="0"/>
              <a:t>Newly housed</a:t>
            </a:r>
          </a:p>
          <a:p>
            <a:r>
              <a:rPr lang="en-US" sz="1000" dirty="0"/>
              <a:t>Stably housed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6705600" y="4378325"/>
            <a:ext cx="914400" cy="861774"/>
          </a:xfrm>
          <a:prstGeom prst="rect">
            <a:avLst/>
          </a:prstGeom>
          <a:noFill/>
          <a:ln w="9525" cmpd="sng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00" dirty="0"/>
              <a:t>Retention in treatment and care</a:t>
            </a:r>
          </a:p>
          <a:p>
            <a:r>
              <a:rPr lang="en-US" sz="1000" dirty="0"/>
              <a:t>Re-incarceration</a:t>
            </a:r>
          </a:p>
        </p:txBody>
      </p:sp>
    </p:spTree>
    <p:extLst>
      <p:ext uri="{BB962C8B-B14F-4D97-AF65-F5344CB8AC3E}">
        <p14:creationId xmlns:p14="http://schemas.microsoft.com/office/powerpoint/2010/main" val="3925857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</TotalTime>
  <Words>70</Words>
  <Application>Microsoft Office PowerPoint</Application>
  <PresentationFormat>On-screen Show (4:3)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my Althoff</dc:creator>
  <cp:lastModifiedBy>Meyer, Jaimie</cp:lastModifiedBy>
  <cp:revision>12</cp:revision>
  <dcterms:created xsi:type="dcterms:W3CDTF">2012-03-31T20:30:33Z</dcterms:created>
  <dcterms:modified xsi:type="dcterms:W3CDTF">2023-01-13T16:27:50Z</dcterms:modified>
</cp:coreProperties>
</file>